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73" d="100"/>
          <a:sy n="73" d="100"/>
        </p:scale>
        <p:origin x="-630" y="-10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AD04E178-43E9-4D7D-937A-5209B806668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xmlns="" id="{66CF993A-FF7E-4AC2-AE84-EB737EBA038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345C51FB-D90E-48A2-9F8B-0F663AED92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3C6F9-D5A3-41F3-A860-D4D125FBDB71}" type="datetimeFigureOut">
              <a:rPr lang="en-GB" smtClean="0"/>
              <a:pPr/>
              <a:t>26/11/2019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15BBC38C-E5EA-412E-A78B-355206226E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F050D109-DEEF-4532-8C6F-B054412D96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340148-2355-4687-B59F-1BD03DC723F5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8307704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92709A3F-FABB-480A-9D3C-A587A2810ED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6E0B53B3-CD25-4386-9C91-2D83EED51BC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C58452ED-D6C2-449A-9142-F30C655B53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3C6F9-D5A3-41F3-A860-D4D125FBDB71}" type="datetimeFigureOut">
              <a:rPr lang="en-GB" smtClean="0"/>
              <a:pPr/>
              <a:t>26/11/2019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3B910DFA-088D-4F46-B4E7-BA1133A6CF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485C0267-BD62-49FC-A38F-17EFE67496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340148-2355-4687-B59F-1BD03DC723F5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30088288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xmlns="" id="{5414274C-8A4D-4041-87AB-35826077D0A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033D4633-7B73-4C81-9091-4486CC28E0E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5F85CFA0-66D8-4FB2-A76A-40DB539776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3C6F9-D5A3-41F3-A860-D4D125FBDB71}" type="datetimeFigureOut">
              <a:rPr lang="en-GB" smtClean="0"/>
              <a:pPr/>
              <a:t>26/11/2019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C970D385-8FFE-43B6-AA62-C43D2F8F2F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0B984E8C-AF6A-44DB-A9E5-4098DC0E25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340148-2355-4687-B59F-1BD03DC723F5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6375615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6633DD2D-F39A-4759-90C6-A63B76CFC7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88AD1255-8DDD-4EE2-B4FE-C5D261139EC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B7095ABC-50DA-40D3-AD32-1C9776BD82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3C6F9-D5A3-41F3-A860-D4D125FBDB71}" type="datetimeFigureOut">
              <a:rPr lang="en-GB" smtClean="0"/>
              <a:pPr/>
              <a:t>26/11/2019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A927D6EB-1E96-4CAC-AB47-176E541FBE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0CFC984F-8001-4C59-A364-0295B06C42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340148-2355-4687-B59F-1BD03DC723F5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8566723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0C0207AF-686C-49D0-B842-78418F46D9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2FC8CFA4-187C-479B-85FE-288BAF46FA1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EA6987F2-279A-4E76-AB70-CE084F5628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3C6F9-D5A3-41F3-A860-D4D125FBDB71}" type="datetimeFigureOut">
              <a:rPr lang="en-GB" smtClean="0"/>
              <a:pPr/>
              <a:t>26/11/2019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49FDCABA-CB46-4892-BCAE-A6B50DB924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1D3BBE60-2D51-4E72-8333-578956B3FD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340148-2355-4687-B59F-1BD03DC723F5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30132742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89B0BF8D-BBF6-4D45-B6CF-FBC51F28208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F2B197A4-A237-4DC9-9E43-C760D689A50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31EBA3E0-D4F0-4B69-A49A-F3A3AF5F111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3F6FB33B-BBCC-49B7-980C-3D5F76C59E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3C6F9-D5A3-41F3-A860-D4D125FBDB71}" type="datetimeFigureOut">
              <a:rPr lang="en-GB" smtClean="0"/>
              <a:pPr/>
              <a:t>26/11/2019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481584BD-21E9-439C-A18F-E06F5056AB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1D645528-1CA3-4782-87D4-8D5B8F5EDA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340148-2355-4687-B59F-1BD03DC723F5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4237934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4BFCF860-5E2B-459D-8F13-788693D3C2E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11B0E0A5-FEAA-49CE-A15D-14AAD53E432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6BCAE8CB-34B0-4F11-BCCA-26EB42A3EE7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xmlns="" id="{0CBFDC0D-12D6-4C11-8D10-597BA6843E3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xmlns="" id="{F26E5EEE-E63B-4FD8-A0AE-486199A51CE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xmlns="" id="{1EADFDE8-2D20-4302-8FA5-93C084013E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3C6F9-D5A3-41F3-A860-D4D125FBDB71}" type="datetimeFigureOut">
              <a:rPr lang="en-GB" smtClean="0"/>
              <a:pPr/>
              <a:t>26/11/2019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xmlns="" id="{974AEBC5-9C20-4B1E-8733-3A74E0BFED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xmlns="" id="{9A0A6632-1A0E-46A2-A4B2-72F03BAAF6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340148-2355-4687-B59F-1BD03DC723F5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0590131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99F1A21F-167E-45F9-B803-D2C2FAE2704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xmlns="" id="{B829E2D9-6AEC-4569-B1FD-9B2D3B6833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3C6F9-D5A3-41F3-A860-D4D125FBDB71}" type="datetimeFigureOut">
              <a:rPr lang="en-GB" smtClean="0"/>
              <a:pPr/>
              <a:t>26/11/2019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xmlns="" id="{FD7DF2C0-24A2-49DB-A20A-823A256ADD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xmlns="" id="{6FFA9451-06E6-4245-A333-4607C8AC80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340148-2355-4687-B59F-1BD03DC723F5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8511350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xmlns="" id="{20E7609D-62BE-4822-AD9B-9CB2BE0D56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3C6F9-D5A3-41F3-A860-D4D125FBDB71}" type="datetimeFigureOut">
              <a:rPr lang="en-GB" smtClean="0"/>
              <a:pPr/>
              <a:t>26/11/2019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xmlns="" id="{9AB5224C-F24D-4AF7-BF99-39260CADAA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xmlns="" id="{AA0621ED-3541-4802-92B3-F7C9961993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340148-2355-4687-B59F-1BD03DC723F5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36089962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CC00F167-85C2-415D-9AFE-3CB110AF387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E2E7E5D5-FAB0-41D3-A7DE-E5E62DB711D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E3B8463B-EC89-4F2D-87EA-43A7B6060E3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2AD0D955-ACCC-4523-BB22-2572AA0C15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3C6F9-D5A3-41F3-A860-D4D125FBDB71}" type="datetimeFigureOut">
              <a:rPr lang="en-GB" smtClean="0"/>
              <a:pPr/>
              <a:t>26/11/2019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427A1CEE-D0F0-4601-A4C7-35F2E1FB25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44E58825-BF89-4C52-A128-60A8A274E8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340148-2355-4687-B59F-1BD03DC723F5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174481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7B0150D5-DF56-43AA-8B2C-59EFD81FC3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xmlns="" id="{B0A0408A-B3A2-48F4-92FF-59F98B90BC1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52C3B4C7-E637-40D5-AB89-12CA11DCC35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F36B03E3-4745-4CF7-8FBA-315AAF0C6B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3C6F9-D5A3-41F3-A860-D4D125FBDB71}" type="datetimeFigureOut">
              <a:rPr lang="en-GB" smtClean="0"/>
              <a:pPr/>
              <a:t>26/11/2019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D1C22FB0-0754-4CFC-842C-66CF4D6CB2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B44E9AD6-6AF4-483C-84CC-524DE460B5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340148-2355-4687-B59F-1BD03DC723F5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4812553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xmlns="" id="{F9EAA5B2-C8F8-44A5-83A9-F7701BCF67E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6585E780-39AA-4115-92E3-EC39B98B06E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BCB1514D-36BF-4C5F-B259-9AD1EF97EDC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C3C6F9-D5A3-41F3-A860-D4D125FBDB71}" type="datetimeFigureOut">
              <a:rPr lang="en-GB" smtClean="0"/>
              <a:pPr/>
              <a:t>26/11/2019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1E862462-B7EE-46AC-8120-596EB76029B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5F1B1CDC-6A8D-49C8-941C-455A34546BA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340148-2355-4687-B59F-1BD03DC723F5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3981186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xmlns="" id="{B42AEDEC-D5A9-425A-9ADF-E9AA31870A32}"/>
              </a:ext>
            </a:extLst>
          </p:cNvPr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3006290" y="143869"/>
            <a:ext cx="5223310" cy="4646426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xmlns="" id="{BEC23E7A-A268-4AF1-A55D-00B6D6F0B213}"/>
              </a:ext>
            </a:extLst>
          </p:cNvPr>
          <p:cNvSpPr/>
          <p:nvPr/>
        </p:nvSpPr>
        <p:spPr>
          <a:xfrm>
            <a:off x="3328604" y="4770545"/>
            <a:ext cx="6096000" cy="1754326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GB" b="1" dirty="0" smtClean="0">
                <a:latin typeface="Calibri Light" panose="020F0302020204030204" pitchFamily="34" charset="0"/>
                <a:ea typeface="Calibri" panose="020F0502020204030204" pitchFamily="34" charset="0"/>
              </a:rPr>
              <a:t>Additional </a:t>
            </a:r>
            <a:r>
              <a:rPr lang="en-GB" b="1" dirty="0">
                <a:latin typeface="Calibri Light" panose="020F0302020204030204" pitchFamily="34" charset="0"/>
                <a:ea typeface="Calibri" panose="020F0502020204030204" pitchFamily="34" charset="0"/>
              </a:rPr>
              <a:t>Figure </a:t>
            </a:r>
            <a:r>
              <a:rPr lang="en-GB" b="1" smtClean="0">
                <a:latin typeface="Calibri Light" panose="020F0302020204030204" pitchFamily="34" charset="0"/>
                <a:ea typeface="Calibri" panose="020F0502020204030204" pitchFamily="34" charset="0"/>
              </a:rPr>
              <a:t>S8</a:t>
            </a:r>
            <a:r>
              <a:rPr lang="en-GB" dirty="0">
                <a:latin typeface="Calibri Light" panose="020F0302020204030204" pitchFamily="34" charset="0"/>
                <a:ea typeface="Calibri" panose="020F0502020204030204" pitchFamily="34" charset="0"/>
              </a:rPr>
              <a:t>: Mean predicted </a:t>
            </a:r>
            <a:r>
              <a:rPr lang="en-GB" i="1" dirty="0">
                <a:latin typeface="Calibri Light" panose="020F0302020204030204" pitchFamily="34" charset="0"/>
                <a:ea typeface="Calibri" panose="020F0502020204030204" pitchFamily="34" charset="0"/>
              </a:rPr>
              <a:t>Plasmodium falciparum</a:t>
            </a:r>
            <a:r>
              <a:rPr lang="en-GB" dirty="0">
                <a:latin typeface="Calibri Light" panose="020F0302020204030204" pitchFamily="34" charset="0"/>
                <a:ea typeface="Calibri" panose="020F0502020204030204" pitchFamily="34" charset="0"/>
              </a:rPr>
              <a:t> infection rate in </a:t>
            </a:r>
            <a:r>
              <a:rPr lang="en-US" dirty="0">
                <a:latin typeface="Calibri Light" panose="020F0302020204030204" pitchFamily="34" charset="0"/>
                <a:ea typeface="Calibri" panose="020F0502020204030204" pitchFamily="34" charset="0"/>
              </a:rPr>
              <a:t>An. gambiae s.l. collected per </a:t>
            </a:r>
            <a:r>
              <a:rPr lang="en-GB" dirty="0">
                <a:latin typeface="Calibri Light" panose="020F0302020204030204" pitchFamily="34" charset="0"/>
                <a:ea typeface="Calibri" panose="020F0502020204030204" pitchFamily="34" charset="0"/>
              </a:rPr>
              <a:t>village</a:t>
            </a:r>
            <a:r>
              <a:rPr lang="en-US" dirty="0">
                <a:latin typeface="Calibri Light" panose="020F0302020204030204" pitchFamily="34" charset="0"/>
                <a:ea typeface="Calibri" panose="020F0502020204030204" pitchFamily="34" charset="0"/>
              </a:rPr>
              <a:t> from October 2016 to December 2017, pooled over the trapping location and methods, with 95% CIs.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xmlns="" val="42258582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39</Words>
  <Application>Microsoft Office PowerPoint</Application>
  <PresentationFormat>Custom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TOINE SANOU (student)</dc:creator>
  <cp:lastModifiedBy>0013914</cp:lastModifiedBy>
  <cp:revision>5</cp:revision>
  <dcterms:created xsi:type="dcterms:W3CDTF">2019-03-05T20:03:24Z</dcterms:created>
  <dcterms:modified xsi:type="dcterms:W3CDTF">2019-11-26T07:16:14Z</dcterms:modified>
</cp:coreProperties>
</file>